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493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776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749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233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165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755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69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414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15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301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482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975CF5-FDE7-447F-BC72-62B4073837B1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2E312-80BB-4C1B-93E0-0258B91B77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619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40378" t="37469" r="31802" b="28992"/>
          <a:stretch/>
        </p:blipFill>
        <p:spPr>
          <a:xfrm>
            <a:off x="2813578" y="887059"/>
            <a:ext cx="6061570" cy="37338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718801" y="4620859"/>
            <a:ext cx="934339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3. Effect  of dietary treatment on intestinal epithelial permeability</a:t>
            </a:r>
            <a:r>
              <a:rPr lang="en-US" dirty="0"/>
              <a:t>.  Intestinal jejunum</a:t>
            </a:r>
          </a:p>
          <a:p>
            <a:r>
              <a:rPr lang="en-US"/>
              <a:t>mucosae </a:t>
            </a:r>
            <a:r>
              <a:rPr lang="en-US" dirty="0"/>
              <a:t>were mounted in Snap-wells and trans-epithelial electrical resistance (TEER</a:t>
            </a:r>
            <a:r>
              <a:rPr lang="en-US"/>
              <a:t>) measured </a:t>
            </a:r>
          </a:p>
          <a:p>
            <a:r>
              <a:rPr lang="en-US"/>
              <a:t>at </a:t>
            </a:r>
            <a:r>
              <a:rPr lang="en-US" dirty="0"/>
              <a:t>0, 30, 60, 90, 120 minutes. Bars represent mean TEER ± SE (n=10-11/treatment). Three servings</a:t>
            </a:r>
          </a:p>
          <a:p>
            <a:r>
              <a:rPr lang="en-US" dirty="0"/>
              <a:t>vs 6 servings (p=0.08); no other differences were detected among groups.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6035"/>
          <a:stretch/>
        </p:blipFill>
        <p:spPr>
          <a:xfrm>
            <a:off x="4134863" y="462032"/>
            <a:ext cx="4035550" cy="208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80806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6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ano-Aguilar, Gloria</dc:creator>
  <cp:lastModifiedBy>Solano-Aguilar, Gloria</cp:lastModifiedBy>
  <cp:revision>6</cp:revision>
  <dcterms:created xsi:type="dcterms:W3CDTF">2018-09-19T14:27:40Z</dcterms:created>
  <dcterms:modified xsi:type="dcterms:W3CDTF">2018-11-07T23:14:51Z</dcterms:modified>
</cp:coreProperties>
</file>